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2" r:id="rId5"/>
    <p:sldId id="263" r:id="rId6"/>
    <p:sldId id="264" r:id="rId7"/>
    <p:sldId id="259" r:id="rId8"/>
    <p:sldId id="260" r:id="rId9"/>
    <p:sldId id="261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CC2D6"/>
    <a:srgbClr val="3366FF"/>
  </p:clrMru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25" d="100"/>
          <a:sy n="125" d="100"/>
        </p:scale>
        <p:origin x="-1224" y="-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2B68F-2898-40D9-A17A-68B7ED3E2255}" type="datetimeFigureOut">
              <a:rPr lang="en-US" smtClean="0"/>
              <a:pPr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D54F1A-8018-4D6A-BF6B-43F93D2AC5F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ncbi.nlm.nih.gov/" TargetMode="Externa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1.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presentative proteome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IN" sz="1200" dirty="0">
                <a:latin typeface="Arial" pitchFamily="34" charset="0"/>
                <a:cs typeface="Arial" pitchFamily="34" charset="0"/>
              </a:rPr>
              <a:t>profile of 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R. rettgeri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ntrol or cadmium treated cells following 1h of exposure to 1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pm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admium. Cellular proteins (50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μ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were resolv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so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electric focusing (17cm IPG strip,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4-7, Bio-Rad, India) by cup loading method followed by 12% SDS-PAGE.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The </a:t>
            </a:r>
            <a:r>
              <a:rPr lang="en-IN" sz="1200" dirty="0" err="1">
                <a:latin typeface="Arial" pitchFamily="34" charset="0"/>
                <a:cs typeface="Arial" pitchFamily="34" charset="0"/>
              </a:rPr>
              <a:t>pI</a:t>
            </a:r>
            <a:r>
              <a:rPr lang="en-IN" sz="1200" dirty="0">
                <a:latin typeface="Arial" pitchFamily="34" charset="0"/>
                <a:cs typeface="Arial" pitchFamily="34" charset="0"/>
              </a:rPr>
              <a:t> and molecular masses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kDa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) of </a:t>
            </a:r>
            <a:r>
              <a:rPr lang="en-IN" sz="1200" dirty="0">
                <a:latin typeface="Arial" pitchFamily="34" charset="0"/>
                <a:cs typeface="Arial" pitchFamily="34" charset="0"/>
              </a:rPr>
              <a:t>marker proteins are shown at the top and at right hand side of the gel, respectively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5232" y="1622344"/>
            <a:ext cx="3902911" cy="40266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43098" y="1622344"/>
            <a:ext cx="4106427" cy="40266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5" name="Group 4"/>
          <p:cNvGrpSpPr/>
          <p:nvPr/>
        </p:nvGrpSpPr>
        <p:grpSpPr>
          <a:xfrm>
            <a:off x="330117" y="1355996"/>
            <a:ext cx="3638286" cy="237048"/>
            <a:chOff x="679986" y="452410"/>
            <a:chExt cx="3903346" cy="254318"/>
          </a:xfrm>
        </p:grpSpPr>
        <p:cxnSp>
          <p:nvCxnSpPr>
            <p:cNvPr id="6" name="Straight Arrow Connector 5"/>
            <p:cNvCxnSpPr/>
            <p:nvPr/>
          </p:nvCxnSpPr>
          <p:spPr>
            <a:xfrm>
              <a:off x="743926" y="665770"/>
              <a:ext cx="37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679986" y="452410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IN" sz="105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323324" y="452812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dirty="0" smtClean="0">
                  <a:latin typeface="Arial" pitchFamily="34" charset="0"/>
                  <a:cs typeface="Arial" pitchFamily="34" charset="0"/>
                </a:rPr>
                <a:t>7</a:t>
              </a:r>
              <a:endParaRPr lang="en-IN" sz="105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0" name="Straight Arrow Connector 9"/>
          <p:cNvCxnSpPr/>
          <p:nvPr/>
        </p:nvCxnSpPr>
        <p:spPr>
          <a:xfrm>
            <a:off x="4297610" y="1554868"/>
            <a:ext cx="3623982" cy="148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238012" y="1355996"/>
            <a:ext cx="242352" cy="2366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50" dirty="0" smtClean="0">
                <a:latin typeface="Arial" pitchFamily="34" charset="0"/>
                <a:cs typeface="Arial" pitchFamily="34" charset="0"/>
              </a:rPr>
              <a:t>4</a:t>
            </a:r>
            <a:endParaRPr lang="en-IN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745264" y="1356371"/>
            <a:ext cx="242352" cy="2366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50" dirty="0" smtClean="0">
                <a:latin typeface="Arial" pitchFamily="34" charset="0"/>
                <a:cs typeface="Arial" pitchFamily="34" charset="0"/>
              </a:rPr>
              <a:t>7</a:t>
            </a:r>
            <a:endParaRPr lang="en-IN" sz="105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8251006" y="1642232"/>
            <a:ext cx="654929" cy="3371199"/>
            <a:chOff x="8251006" y="1642232"/>
            <a:chExt cx="654929" cy="3371199"/>
          </a:xfrm>
        </p:grpSpPr>
        <p:sp>
          <p:nvSpPr>
            <p:cNvPr id="30" name="TextBox 29"/>
            <p:cNvSpPr txBox="1"/>
            <p:nvPr/>
          </p:nvSpPr>
          <p:spPr>
            <a:xfrm>
              <a:off x="8291664" y="1642232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175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291664" y="1779378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130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309837" y="195513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95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310714" y="2151343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70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310714" y="2333918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62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310714" y="2507408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51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310714" y="2687711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42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291664" y="3294618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29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291664" y="3985220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22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291664" y="4782599"/>
              <a:ext cx="5501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dirty="0" smtClean="0">
                  <a:latin typeface="Arial" pitchFamily="34" charset="0"/>
                  <a:cs typeface="Arial" pitchFamily="34" charset="0"/>
                </a:rPr>
                <a:t>14 </a:t>
              </a:r>
              <a:r>
                <a:rPr lang="en-IN" sz="900" dirty="0" err="1" smtClean="0">
                  <a:latin typeface="Arial" pitchFamily="34" charset="0"/>
                  <a:cs typeface="Arial" pitchFamily="34" charset="0"/>
                </a:rPr>
                <a:t>kDa</a:t>
              </a:r>
              <a:endParaRPr lang="en-IN" sz="9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8251006" y="1767935"/>
              <a:ext cx="137376" cy="3138168"/>
              <a:chOff x="8585228" y="1789043"/>
              <a:chExt cx="144000" cy="3289381"/>
            </a:xfrm>
          </p:grpSpPr>
          <p:cxnSp>
            <p:nvCxnSpPr>
              <p:cNvPr id="15" name="Straight Connector 14"/>
              <p:cNvCxnSpPr/>
              <p:nvPr/>
            </p:nvCxnSpPr>
            <p:spPr>
              <a:xfrm>
                <a:off x="8585228" y="1789043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8585228" y="1928740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8585228" y="2112884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8585228" y="2316079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>
                <a:off x="8585228" y="2506574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8585228" y="2690718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8585228" y="2881214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8585228" y="3514611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8585228" y="4240078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8585228" y="5076836"/>
                <a:ext cx="1440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7" name="TextBox 26"/>
          <p:cNvSpPr txBox="1"/>
          <p:nvPr/>
        </p:nvSpPr>
        <p:spPr>
          <a:xfrm>
            <a:off x="1688092" y="1328990"/>
            <a:ext cx="885973" cy="264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IN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283677" y="1328990"/>
            <a:ext cx="16356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 err="1" smtClean="0">
                <a:latin typeface="Arial" pitchFamily="34" charset="0"/>
                <a:cs typeface="Arial" pitchFamily="34" charset="0"/>
              </a:rPr>
              <a:t>Cd</a:t>
            </a:r>
            <a:r>
              <a:rPr lang="en-IN" sz="1200" b="1" dirty="0" smtClean="0">
                <a:latin typeface="Arial" pitchFamily="34" charset="0"/>
                <a:cs typeface="Arial" pitchFamily="34" charset="0"/>
              </a:rPr>
              <a:t> treated</a:t>
            </a:r>
            <a:endParaRPr lang="en-IN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2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Hierarchical cluster of all the identified proteins according to their expression levels in 3 replicates each of control (C1, C2, C3) an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d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treated (T1, T2, T3) cells. The clusters are further divided into sub-clusters according to expression pattern of their constituent proteins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445848" y="1172272"/>
            <a:ext cx="8253243" cy="5400000"/>
            <a:chOff x="2143108" y="1000108"/>
            <a:chExt cx="8253243" cy="5400000"/>
          </a:xfrm>
        </p:grpSpPr>
        <p:pic>
          <p:nvPicPr>
            <p:cNvPr id="3" name="Picture 2" descr="Cluster_Total_1.jpe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143108" y="1000108"/>
              <a:ext cx="3618336" cy="5400000"/>
            </a:xfrm>
            <a:prstGeom prst="rect">
              <a:avLst/>
            </a:prstGeom>
          </p:spPr>
        </p:pic>
        <p:grpSp>
          <p:nvGrpSpPr>
            <p:cNvPr id="11" name="Group 10"/>
            <p:cNvGrpSpPr/>
            <p:nvPr/>
          </p:nvGrpSpPr>
          <p:grpSpPr>
            <a:xfrm>
              <a:off x="5829312" y="1296338"/>
              <a:ext cx="184148" cy="5073636"/>
              <a:chOff x="5829312" y="1296338"/>
              <a:chExt cx="184148" cy="5073636"/>
            </a:xfrm>
          </p:grpSpPr>
          <p:sp>
            <p:nvSpPr>
              <p:cNvPr id="4" name="Right Brace 3"/>
              <p:cNvSpPr/>
              <p:nvPr/>
            </p:nvSpPr>
            <p:spPr>
              <a:xfrm>
                <a:off x="5830284" y="1296338"/>
                <a:ext cx="180000" cy="2052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Right Brace 4"/>
              <p:cNvSpPr/>
              <p:nvPr/>
            </p:nvSpPr>
            <p:spPr>
              <a:xfrm>
                <a:off x="5831555" y="2086918"/>
                <a:ext cx="180000" cy="6120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Right Brace 5"/>
              <p:cNvSpPr/>
              <p:nvPr/>
            </p:nvSpPr>
            <p:spPr>
              <a:xfrm>
                <a:off x="5829967" y="2701112"/>
                <a:ext cx="180000" cy="1080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Right Brace 7"/>
              <p:cNvSpPr/>
              <p:nvPr/>
            </p:nvSpPr>
            <p:spPr>
              <a:xfrm>
                <a:off x="5829650" y="2808918"/>
                <a:ext cx="180000" cy="14580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" name="Right Brace 8"/>
              <p:cNvSpPr/>
              <p:nvPr/>
            </p:nvSpPr>
            <p:spPr>
              <a:xfrm>
                <a:off x="5832190" y="4264636"/>
                <a:ext cx="180000" cy="15552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ight Brace 9"/>
              <p:cNvSpPr/>
              <p:nvPr/>
            </p:nvSpPr>
            <p:spPr>
              <a:xfrm>
                <a:off x="5833460" y="5829974"/>
                <a:ext cx="180000" cy="5400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ight Brace 12"/>
              <p:cNvSpPr/>
              <p:nvPr/>
            </p:nvSpPr>
            <p:spPr>
              <a:xfrm>
                <a:off x="5829312" y="1509288"/>
                <a:ext cx="180000" cy="576000"/>
              </a:xfrm>
              <a:prstGeom prst="rightBrace">
                <a:avLst/>
              </a:prstGeom>
              <a:ln w="1270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5947420" y="1270620"/>
              <a:ext cx="1947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Highly expressed protein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959802" y="1659423"/>
              <a:ext cx="28103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Moderate-high expression of protein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972184" y="2261407"/>
              <a:ext cx="2085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ow expression of protein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984566" y="2627942"/>
              <a:ext cx="44117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roteins significantly down-regulated in Cadmium treated cell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996948" y="3404415"/>
              <a:ext cx="43781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roteins moderately down-regulated in Cadmium treated cell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009330" y="4904613"/>
              <a:ext cx="4182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roteins moderately up-regulated in Cadmium treated cell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021712" y="5965526"/>
              <a:ext cx="42162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Proteins significantly up-regulated in Cadmium treated cell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3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A) Presence of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ahp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ahpF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genes on the genome of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P. rettger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 in an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opero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rrangement. List of adjacent genes is given below. (Source: </a:t>
            </a:r>
            <a:r>
              <a:rPr lang="en-US" sz="1200" dirty="0" smtClean="0">
                <a:latin typeface="Arial" pitchFamily="34" charset="0"/>
                <a:cs typeface="Arial" pitchFamily="34" charset="0"/>
                <a:hlinkClick r:id="rId2"/>
              </a:rPr>
              <a:t>https://www.ncbi.nlm.nih.gov/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(B) The sequence of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P. rettgeri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Ahp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rotein. Th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eroxidati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47, N-terminal) and resolving (166, C-terminal)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cystei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sidues are shown in blue and green bold letters, respectively. The protein has 2 domains: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hioredoxi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residues 4-159, blue letters) an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eroxiredoxin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residues 158-183, green letters). Two amino acid residues at the interface of 2 domains (158-159) are shown in cyan color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331758" y="2857496"/>
          <a:ext cx="8501122" cy="99997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35718"/>
                <a:gridCol w="1135918"/>
                <a:gridCol w="785818"/>
                <a:gridCol w="1071570"/>
                <a:gridCol w="1928826"/>
                <a:gridCol w="3143272"/>
              </a:tblGrid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 err="1">
                          <a:latin typeface="Arial" pitchFamily="34" charset="0"/>
                          <a:cs typeface="Arial" pitchFamily="34" charset="0"/>
                        </a:rPr>
                        <a:t>tax_i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latin typeface="Arial" pitchFamily="34" charset="0"/>
                          <a:cs typeface="Arial" pitchFamily="34" charset="0"/>
                        </a:rPr>
                        <a:t>Org_nam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latin typeface="Arial" pitchFamily="34" charset="0"/>
                          <a:cs typeface="Arial" pitchFamily="34" charset="0"/>
                        </a:rPr>
                        <a:t>GeneI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latin typeface="Arial" pitchFamily="34" charset="0"/>
                          <a:cs typeface="Arial" pitchFamily="34" charset="0"/>
                        </a:rPr>
                        <a:t>Symbol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latin typeface="Arial" pitchFamily="34" charset="0"/>
                          <a:cs typeface="Arial" pitchFamily="34" charset="0"/>
                        </a:rPr>
                        <a:t>Aliase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latin typeface="Arial" pitchFamily="34" charset="0"/>
                          <a:cs typeface="Arial" pitchFamily="34" charset="0"/>
                        </a:rPr>
                        <a:t>descrip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58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rovidencia rettger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614180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M461_RS127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M461_RS12705, AM461_127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seud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5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rovidencia rettger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614180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>
                          <a:latin typeface="Arial" pitchFamily="34" charset="0"/>
                          <a:cs typeface="Arial" pitchFamily="34" charset="0"/>
                        </a:rPr>
                        <a:t>ahpF</a:t>
                      </a:r>
                      <a:endParaRPr lang="en-US" sz="900" b="0" i="1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AM461_RS12700, AM461_127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lkyl hydroperoxide reductase subunit 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5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rovidencia rettger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614180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ahpC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AM461_RS12695, AM461_1269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u="none" strike="noStrike">
                          <a:latin typeface="Arial" pitchFamily="34" charset="0"/>
                          <a:cs typeface="Arial" pitchFamily="34" charset="0"/>
                        </a:rPr>
                        <a:t>alkyl hydroperoxide reductase subunit C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5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rovidencia rettger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614180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M461_RS126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M461_RS12690, AM461_126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ABC transporter </a:t>
                      </a:r>
                      <a:r>
                        <a:rPr lang="en-US" sz="900" u="none" strike="noStrike" dirty="0" err="1">
                          <a:latin typeface="Arial" pitchFamily="34" charset="0"/>
                          <a:cs typeface="Arial" pitchFamily="34" charset="0"/>
                        </a:rPr>
                        <a:t>perme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5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rovidencia rettger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614180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i="1" u="none" strike="noStrike" dirty="0" err="1">
                          <a:latin typeface="Arial" pitchFamily="34" charset="0"/>
                          <a:cs typeface="Arial" pitchFamily="34" charset="0"/>
                        </a:rPr>
                        <a:t>rbbA</a:t>
                      </a:r>
                      <a:endParaRPr lang="en-US" sz="900" b="0" i="1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M461_RS12685, AM461_126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ribosome-associated ATPase/putative transporter Rbb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13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5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Providencia rettger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614180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AM461_RS1268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latin typeface="Arial" pitchFamily="34" charset="0"/>
                          <a:cs typeface="Arial" pitchFamily="34" charset="0"/>
                        </a:rPr>
                        <a:t>AM461_RS12680, AM461_1268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 err="1">
                          <a:latin typeface="Arial" pitchFamily="34" charset="0"/>
                          <a:cs typeface="Arial" pitchFamily="34" charset="0"/>
                        </a:rPr>
                        <a:t>HlyD</a:t>
                      </a:r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 family efflux transporter </a:t>
                      </a:r>
                      <a:r>
                        <a:rPr lang="en-US" sz="900" u="none" strike="noStrike" dirty="0" err="1">
                          <a:latin typeface="Arial" pitchFamily="34" charset="0"/>
                          <a:cs typeface="Arial" pitchFamily="34" charset="0"/>
                        </a:rPr>
                        <a:t>periplasmic</a:t>
                      </a:r>
                      <a:r>
                        <a:rPr lang="en-US" sz="900" u="none" strike="noStrike" dirty="0">
                          <a:latin typeface="Arial" pitchFamily="34" charset="0"/>
                          <a:cs typeface="Arial" pitchFamily="34" charset="0"/>
                        </a:rPr>
                        <a:t> adaptor subuni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694" marR="5694" marT="56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</a:tbl>
          </a:graphicData>
        </a:graphic>
      </p:graphicFrame>
      <p:grpSp>
        <p:nvGrpSpPr>
          <p:cNvPr id="17" name="Group 16"/>
          <p:cNvGrpSpPr/>
          <p:nvPr/>
        </p:nvGrpSpPr>
        <p:grpSpPr>
          <a:xfrm>
            <a:off x="1357290" y="1770810"/>
            <a:ext cx="6408000" cy="854582"/>
            <a:chOff x="1428728" y="1569223"/>
            <a:chExt cx="6408000" cy="854582"/>
          </a:xfrm>
        </p:grpSpPr>
        <p:cxnSp>
          <p:nvCxnSpPr>
            <p:cNvPr id="9" name="Straight Connector 8"/>
            <p:cNvCxnSpPr/>
            <p:nvPr/>
          </p:nvCxnSpPr>
          <p:spPr>
            <a:xfrm rot="10800000" flipH="1">
              <a:off x="1428728" y="1928803"/>
              <a:ext cx="6408000" cy="1588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1928794" y="1962140"/>
              <a:ext cx="125707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i="1" dirty="0" err="1" smtClean="0">
                  <a:latin typeface="Arial" pitchFamily="34" charset="0"/>
                  <a:cs typeface="Arial" pitchFamily="34" charset="0"/>
                </a:rPr>
                <a:t>ahpC</a:t>
              </a:r>
              <a:endParaRPr lang="en-US" sz="1200" i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564 nucleotide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565650" y="1960552"/>
              <a:ext cx="134203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i="1" dirty="0" err="1" smtClean="0">
                  <a:latin typeface="Arial" pitchFamily="34" charset="0"/>
                  <a:cs typeface="Arial" pitchFamily="34" charset="0"/>
                </a:rPr>
                <a:t>ahpF</a:t>
              </a:r>
              <a:endParaRPr lang="en-US" sz="1200" i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1575 nucleotides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50962" y="1569223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2750478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" name="Straight Connector 12"/>
            <p:cNvCxnSpPr/>
            <p:nvPr/>
          </p:nvCxnSpPr>
          <p:spPr>
            <a:xfrm rot="16260000" flipH="1">
              <a:off x="1864988" y="1857670"/>
              <a:ext cx="154600" cy="1588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6516698" y="1569231"/>
              <a:ext cx="779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2752733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" name="Straight Connector 15"/>
            <p:cNvCxnSpPr/>
            <p:nvPr/>
          </p:nvCxnSpPr>
          <p:spPr>
            <a:xfrm rot="16260000" flipH="1">
              <a:off x="6830724" y="1857678"/>
              <a:ext cx="154600" cy="1588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Right Arrow 5"/>
            <p:cNvSpPr/>
            <p:nvPr/>
          </p:nvSpPr>
          <p:spPr>
            <a:xfrm>
              <a:off x="1947844" y="1825614"/>
              <a:ext cx="1260000" cy="214314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 w="12700"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Arrow 6"/>
            <p:cNvSpPr/>
            <p:nvPr/>
          </p:nvSpPr>
          <p:spPr>
            <a:xfrm>
              <a:off x="3487730" y="1825614"/>
              <a:ext cx="3420000" cy="214314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 w="12700"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TextBox 3"/>
          <p:cNvSpPr txBox="1"/>
          <p:nvPr/>
        </p:nvSpPr>
        <p:spPr>
          <a:xfrm>
            <a:off x="575826" y="13395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 smtClean="0">
                <a:latin typeface="Arial" pitchFamily="34" charset="0"/>
                <a:cs typeface="Arial" pitchFamily="34" charset="0"/>
              </a:rPr>
              <a:t>A.</a:t>
            </a:r>
            <a:endParaRPr lang="en-IN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3"/>
          <p:cNvSpPr txBox="1"/>
          <p:nvPr/>
        </p:nvSpPr>
        <p:spPr>
          <a:xfrm>
            <a:off x="572430" y="400925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 smtClean="0">
                <a:latin typeface="Arial" pitchFamily="34" charset="0"/>
                <a:cs typeface="Arial" pitchFamily="34" charset="0"/>
              </a:rPr>
              <a:t>B.</a:t>
            </a:r>
            <a:endParaRPr lang="en-IN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14348" y="4482780"/>
            <a:ext cx="771878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&gt;WP_004910793.1, Alkyl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hydroperoxid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 err="1" smtClean="0">
                <a:latin typeface="Arial" pitchFamily="34" charset="0"/>
                <a:cs typeface="Arial" pitchFamily="34" charset="0"/>
              </a:rPr>
              <a:t>reductas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subunit C [Providencia]</a:t>
            </a:r>
          </a:p>
          <a:p>
            <a:endParaRPr lang="en-US" sz="14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400" dirty="0" smtClean="0">
                <a:latin typeface="Courier New" pitchFamily="49" charset="0"/>
                <a:cs typeface="Courier New" pitchFamily="49" charset="0"/>
              </a:rPr>
              <a:t>MSL</a:t>
            </a:r>
            <a:r>
              <a:rPr lang="en-US" sz="1400" dirty="0" smtClean="0">
                <a:solidFill>
                  <a:srgbClr val="3366FF"/>
                </a:solidFill>
                <a:latin typeface="Courier New" pitchFamily="49" charset="0"/>
                <a:cs typeface="Courier New" pitchFamily="49" charset="0"/>
              </a:rPr>
              <a:t>INTQIKPFTNQAFKNGEFIEVSEKDVAGKWSVFFFYPADFTFV</a:t>
            </a:r>
            <a:r>
              <a:rPr lang="en-US" sz="1600" b="1" dirty="0" smtClean="0">
                <a:solidFill>
                  <a:srgbClr val="3366FF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400" dirty="0" smtClean="0">
                <a:solidFill>
                  <a:srgbClr val="3366FF"/>
                </a:solidFill>
                <a:latin typeface="Courier New" pitchFamily="49" charset="0"/>
                <a:cs typeface="Courier New" pitchFamily="49" charset="0"/>
              </a:rPr>
              <a:t>PTELGDIADHYEEFQKLGVEIFS</a:t>
            </a:r>
          </a:p>
          <a:p>
            <a:r>
              <a:rPr lang="en-US" sz="1400" dirty="0" smtClean="0">
                <a:solidFill>
                  <a:srgbClr val="3366FF"/>
                </a:solidFill>
                <a:latin typeface="Courier New" pitchFamily="49" charset="0"/>
                <a:cs typeface="Courier New" pitchFamily="49" charset="0"/>
              </a:rPr>
              <a:t>VSTDTHFTHKAWHASSETIGKIKYAMIGDPTGALTRNFENMREDEGLADRGTFVVDPQGIIQAIEVTAEG</a:t>
            </a:r>
          </a:p>
          <a:p>
            <a:r>
              <a:rPr lang="en-US" sz="1400" dirty="0" smtClean="0">
                <a:solidFill>
                  <a:srgbClr val="3366FF"/>
                </a:solidFill>
                <a:latin typeface="Courier New" pitchFamily="49" charset="0"/>
                <a:cs typeface="Courier New" pitchFamily="49" charset="0"/>
              </a:rPr>
              <a:t>IGRDASDLLRKVKAA</a:t>
            </a:r>
            <a:r>
              <a:rPr lang="en-US" sz="1400" dirty="0" smtClean="0">
                <a:solidFill>
                  <a:srgbClr val="5CC2D6"/>
                </a:solidFill>
                <a:latin typeface="Courier New" pitchFamily="49" charset="0"/>
                <a:cs typeface="Courier New" pitchFamily="49" charset="0"/>
              </a:rPr>
              <a:t>QY</a:t>
            </a:r>
            <a:r>
              <a:rPr lang="en-US" sz="1400" dirty="0" smtClean="0">
                <a:solidFill>
                  <a:srgbClr val="00B050"/>
                </a:solidFill>
                <a:latin typeface="Courier New" pitchFamily="49" charset="0"/>
                <a:cs typeface="Courier New" pitchFamily="49" charset="0"/>
              </a:rPr>
              <a:t>VASHPGEV</a:t>
            </a:r>
            <a:r>
              <a:rPr lang="en-US" sz="1600" b="1" dirty="0" smtClean="0">
                <a:solidFill>
                  <a:srgbClr val="00B05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sz="1400" dirty="0" smtClean="0">
                <a:solidFill>
                  <a:srgbClr val="00B050"/>
                </a:solidFill>
                <a:latin typeface="Courier New" pitchFamily="49" charset="0"/>
                <a:cs typeface="Courier New" pitchFamily="49" charset="0"/>
              </a:rPr>
              <a:t>PAKWKEGDATLSPSLD</a:t>
            </a:r>
            <a:r>
              <a:rPr lang="en-US" sz="1400" dirty="0" smtClean="0">
                <a:latin typeface="Courier New" pitchFamily="49" charset="0"/>
                <a:cs typeface="Courier New" pitchFamily="49" charset="0"/>
              </a:rPr>
              <a:t>LVGKI</a:t>
            </a:r>
          </a:p>
          <a:p>
            <a:endParaRPr lang="en-US" sz="1400" dirty="0">
              <a:latin typeface="Courier New" pitchFamily="49" charset="0"/>
              <a:cs typeface="Courier New" pitchFamily="49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7158" y="1367776"/>
            <a:ext cx="6186309" cy="5478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MVLRYNSPRLNILELVLLYVGFFSIGSLNLLQKRKATSDPYRRKNRFGKE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PIGIISWWILGIALTYVVDISNLVIYALRVPNWWPCKTTVVCLILFLLFW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IIVLISCADSKALPKNADSILKAYRLSVLYVWAIDIVFETIFIVYSPHPN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ETFQGIVLADHVARLVLCVFATAIYLTYRRKRHTHDPLDFEERQLTEESN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VNENAISQNPSTVQLGVSASTSNFGTLKSTSKKPSDKSWAEYFRSFSTLL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PYLWPTKDYRLQFQIFICIVLLFLGRAVNILAPRQLGVLTEKLTKHSEKI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PWSDVILFVIYRFLQGNMGVIGSLRSFLWVPVSQYAYRAISTKALRHVLN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LSYDFHLNKRAGEVLTALTKGSSLNTFAEQVVFQIGPVLLDLGVAMVYFF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IKFDIYFTLIVLIMTLCYCYVTVKITSWRTEARRKMVNSWRESYAVQNDA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4.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Sequence alignment between the ABC transporter ATP-binding protein [</a:t>
            </a:r>
            <a:r>
              <a:rPr lang="en-IN" sz="1200" i="1" dirty="0" err="1" smtClean="0">
                <a:latin typeface="Arial" pitchFamily="34" charset="0"/>
                <a:cs typeface="Arial" pitchFamily="34" charset="0"/>
              </a:rPr>
              <a:t>Enterococcus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IN" sz="1200" i="1" dirty="0" err="1" smtClean="0">
                <a:latin typeface="Arial" pitchFamily="34" charset="0"/>
                <a:cs typeface="Arial" pitchFamily="34" charset="0"/>
              </a:rPr>
              <a:t>raffinosus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ATCC 49464] and Heavy metal tolerance protein HMT1 from 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en-IN" sz="1200" i="1" dirty="0" err="1" smtClean="0">
                <a:latin typeface="Arial" pitchFamily="34" charset="0"/>
                <a:cs typeface="Arial" pitchFamily="34" charset="0"/>
              </a:rPr>
              <a:t>pombe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(strain 972 / ATCC24843), performed using 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ClustalW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. Identical residues are indicated by an asterisk and colons or dots respectively denote a conservative or semi-conservative substitution.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57158" y="1367776"/>
            <a:ext cx="6186309" cy="51706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IMNFETVKNFDADDFENERYGHAVDIYLKQERKVLFSLNFLNIVQGGIFT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FSLAIACLLSAYRVTFGFNTVGDFVILLTYMIQLQQPLNFFGTLYRSLQN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------------------------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                   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SIIDTERLLEIFEEKPTVVEKPNAPDLKVTQGKVIFSHVSFAYDPRKPVL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--------------------------MNALEVKKASKTISNGVNDKRKIL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                          ::. : *   . :* . : :: :*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SDINFVAQPGKVIALVGESGGG</a:t>
            </a:r>
            <a:r>
              <a:rPr lang="en-US" sz="1400" b="1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K</a:t>
            </a:r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TIMRILLRFFDVNSGSITIDDQDIRN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NNVDLSIAPGEFVTVLGGNGAGKSTLFNSISGSLQLDSGTVSVMGKDLTK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.::::   **:.::::* .*.****::. :   ::::**:::: .:*: :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VTLSSLRSSIGVVPQD---STLFNDTILYNIKYAKPSATN---EEIYAAA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LSEEQRATSISRVFQDPKMGTAPRLTVAENLGLAEKRGQKRRLRQRQLNQ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:: ..  :**. * **   .*  . *:  *:  *:  . :   .:    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KAAQIHDRILQFPDGYNSRVGERGLKLSGGEKQRVAVARAILKDPSIILL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KKDMYRELCKLVGNGLENHLDTPTGFLSGGQRQALSLLMATITKPDLLLL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*    ::    . :* :.::.     ****::* :::  * :..*.::**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DEATSALDTNTERQIQAALNRLASG--RTAIVIAHRLSTITNADLILCIS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DEHTAALDPKTAKQLMLLTDQRIKEENLTCLMVTHKMEDALHYGDRVIVM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** *:***.:* :*:    ::  .    *.::::*::.   : .  : : </a:t>
            </a:r>
          </a:p>
          <a:p>
            <a:endParaRPr lang="en" sz="10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sp|Q02592|HMT1_SCHPO        NGRIVETGTHEELIKRDGGAYKKMWFQQAMGKTSAETH</a:t>
            </a:r>
          </a:p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tr|R2RIG0|R2RIG0_9ENTE      EKGEIIKDIHGEEKKRMTLADLFLLFEESE--TVAEVM</a:t>
            </a:r>
          </a:p>
          <a:p>
            <a:r>
              <a:rPr lang="en" sz="1000" dirty="0" smtClean="0">
                <a:latin typeface="Courier New" pitchFamily="49" charset="0"/>
                <a:cs typeface="Courier New" pitchFamily="49" charset="0"/>
              </a:rPr>
              <a:t>                            :   : .. * *  **   *   : *:::   * **. </a:t>
            </a:r>
          </a:p>
          <a:p>
            <a:endParaRPr lang="en-US" sz="10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4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ntinued ….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3521" y="1450642"/>
            <a:ext cx="8180445" cy="4524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sp|P0AEM9|TCYJ_ECOLI                MKLAHLGRQALMGVMAVALVAGMSVKSFADEGLLNKVKERGTLLVGLEGT</a:t>
            </a: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tr|A0A2U9L1K8|A0A2U9L1K8_PRORE      --------MKARILTTVLLTGLALTANVASADKLDDIKQAGVIRISVFDS</a:t>
            </a:r>
          </a:p>
          <a:p>
            <a:r>
              <a:rPr lang="en" sz="1200" dirty="0" smtClean="0">
                <a:latin typeface="Courier New" pitchFamily="49" charset="0"/>
                <a:cs typeface="Courier New" pitchFamily="49" charset="0"/>
              </a:rPr>
              <a:t>                                                 : :* *..   . ..*. . *:.:*: *.: :.: .:</a:t>
            </a:r>
          </a:p>
          <a:p>
            <a:endParaRPr lang="en" sz="12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sp|P0AEM9|TCYJ_ECOLI                YPPFSFQG-DDGKLTGFEVEFAQQLAKHLGVEASLKPTKWDGMLASLDSK</a:t>
            </a: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tr|A0A2U9L1K8|A0A2U9L1K8_PRORE      NPPFGFIDPQTKKLAGYDVDIAQEIADSLGVKLELRPTNPANRIPLLTSG</a:t>
            </a:r>
          </a:p>
          <a:p>
            <a:r>
              <a:rPr lang="en" sz="1200" dirty="0" smtClean="0">
                <a:latin typeface="Courier New" pitchFamily="49" charset="0"/>
                <a:cs typeface="Courier New" pitchFamily="49" charset="0"/>
              </a:rPr>
              <a:t>                                     ***.* . :  **:*::*::**::*. ***: .*:**:  . :. * * </a:t>
            </a:r>
          </a:p>
          <a:p>
            <a:endParaRPr lang="en" sz="12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sp|P0AEM9|TCYJ_ECOLI                RIDVVINQVTISDERKKKYDFSTPYTISGIQALVKKGNEGTIKTADDLKG</a:t>
            </a: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tr|A0A2U9L1K8|A0A2U9L1K8_PRORE      KVDLIGANFTITDERAKQVDFSIPDFATGQKFIARKG---VLKTPDDIKP</a:t>
            </a:r>
          </a:p>
          <a:p>
            <a:r>
              <a:rPr lang="en" sz="1200" dirty="0" smtClean="0">
                <a:latin typeface="Courier New" pitchFamily="49" charset="0"/>
                <a:cs typeface="Courier New" pitchFamily="49" charset="0"/>
              </a:rPr>
              <a:t>                                    ::*::  :.**:*** *: *** *   :* : :.:**   .:**.**:* </a:t>
            </a:r>
          </a:p>
          <a:p>
            <a:endParaRPr lang="en" sz="12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sp|P0AEM9|TCYJ_ECOLI                KKVGVGLGTNYEEWLRQNVQGVDVRTYDDDPTKYQDLRVGRIDAILVDRL</a:t>
            </a: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tr|A0A2U9L1K8|A0A2U9L1K8_PRORE      LRIGADKGTVQEVTLRERFPDTKVISYDDTPQAFAALRNGNVQAITQDDA</a:t>
            </a:r>
          </a:p>
          <a:p>
            <a:r>
              <a:rPr lang="en" sz="1200" dirty="0" smtClean="0">
                <a:latin typeface="Courier New" pitchFamily="49" charset="0"/>
                <a:cs typeface="Courier New" pitchFamily="49" charset="0"/>
              </a:rPr>
              <a:t>                                     ::*.. **  *  **:.. ...* :*** *  :  ** *.::**  *  </a:t>
            </a:r>
          </a:p>
          <a:p>
            <a:endParaRPr lang="en" sz="12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sp|P0AEM9|TCYJ_ECOLI                AALDLVK----KTNDTLAVTGEAFSRQESGVALRKGNEDLLKAVNDAIAE</a:t>
            </a: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tr|A0A2U9L1K8|A0A2U9L1K8_PRORE      KLVGLLGNLPEKVKADFEISPFSLTKEYQALAASKGETRLVENVNETLLK</a:t>
            </a:r>
          </a:p>
          <a:p>
            <a:r>
              <a:rPr lang="en" sz="1200" dirty="0" smtClean="0">
                <a:latin typeface="Courier New" pitchFamily="49" charset="0"/>
                <a:cs typeface="Courier New" pitchFamily="49" charset="0"/>
              </a:rPr>
              <a:t>                                      :.*:     *.:  : ::  ::::: ..:*  **:  *:: **::: :</a:t>
            </a:r>
          </a:p>
          <a:p>
            <a:endParaRPr lang="en" sz="1200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sp|P0AEM9|TCYJ_ECOLI                MQKDGTLQALSEKWFGADVTK-------------------</a:t>
            </a:r>
          </a:p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tr|A0A2U9L1K8|A0A2U9L1K8_PRORE      LEKDGKAEVIYNRWFGPDTKAAQPRGDFKFAPLSEQQPQS</a:t>
            </a:r>
          </a:p>
          <a:p>
            <a:r>
              <a:rPr lang="en" sz="1200" dirty="0" smtClean="0">
                <a:latin typeface="Courier New" pitchFamily="49" charset="0"/>
                <a:cs typeface="Courier New" pitchFamily="49" charset="0"/>
              </a:rPr>
              <a:t>                                    ::***. :.: ::***.*..                    </a:t>
            </a:r>
          </a:p>
          <a:p>
            <a:endParaRPr lang="en-US" sz="1200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5.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Sequence alignment between the Amino acid ABC transporter substrate-binding protein (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Sulfate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starvation-induced protein 7) 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FliY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and L-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Cystine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binding protein 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TcyJ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from 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E. coli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, performed using 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ClustalW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. Identical residues are indicated by an asterisk and colons or dots respectively denote a conservative or semi-conservative substitution.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G_0011.jpg"/>
          <p:cNvPicPr>
            <a:picLocks noChangeAspect="1"/>
          </p:cNvPicPr>
          <p:nvPr/>
        </p:nvPicPr>
        <p:blipFill>
          <a:blip r:embed="rId2"/>
          <a:srcRect t="4724" b="2953"/>
          <a:stretch>
            <a:fillRect/>
          </a:stretch>
        </p:blipFill>
        <p:spPr>
          <a:xfrm>
            <a:off x="1868412" y="1114675"/>
            <a:ext cx="5405398" cy="5400000"/>
          </a:xfrm>
          <a:prstGeom prst="rect">
            <a:avLst/>
          </a:prstGeom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6A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The image shows growth of the rice plants at the maturity stage (4 months). The plants were grown in absence of cadmium (C).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G_0010.jpg"/>
          <p:cNvPicPr>
            <a:picLocks noChangeAspect="1"/>
          </p:cNvPicPr>
          <p:nvPr/>
        </p:nvPicPr>
        <p:blipFill>
          <a:blip r:embed="rId2"/>
          <a:srcRect l="15313" r="10625" b="1181"/>
          <a:stretch>
            <a:fillRect/>
          </a:stretch>
        </p:blipFill>
        <p:spPr>
          <a:xfrm>
            <a:off x="1868412" y="1117106"/>
            <a:ext cx="5396188" cy="5400000"/>
          </a:xfrm>
          <a:prstGeom prst="rect">
            <a:avLst/>
          </a:prstGeom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6B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The image shows growth of the rice plants at the maturity stage (4 months). The plants were grown in soil spiked with 100 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ppm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cadmium (T1).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G_0012.jpg"/>
          <p:cNvPicPr>
            <a:picLocks noChangeAspect="1"/>
          </p:cNvPicPr>
          <p:nvPr/>
        </p:nvPicPr>
        <p:blipFill>
          <a:blip r:embed="rId2" cstate="print">
            <a:lum/>
          </a:blip>
          <a:srcRect l="25892" r="12427"/>
          <a:stretch>
            <a:fillRect/>
          </a:stretch>
        </p:blipFill>
        <p:spPr>
          <a:xfrm>
            <a:off x="1783488" y="1142984"/>
            <a:ext cx="5399688" cy="5400000"/>
          </a:xfrm>
          <a:prstGeom prst="rect">
            <a:avLst/>
          </a:prstGeom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494" y="-24"/>
            <a:ext cx="914050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200" b="1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b="1" smtClean="0">
                <a:latin typeface="Arial" pitchFamily="34" charset="0"/>
                <a:cs typeface="Arial" pitchFamily="34" charset="0"/>
              </a:rPr>
              <a:t>S6C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The image shows growth of the rice plants at the maturity stage (4 months). The plants were grown in soil spiked with 100 </a:t>
            </a:r>
            <a:r>
              <a:rPr lang="en-IN" sz="1200" dirty="0" err="1" smtClean="0">
                <a:latin typeface="Arial" pitchFamily="34" charset="0"/>
                <a:cs typeface="Arial" pitchFamily="34" charset="0"/>
              </a:rPr>
              <a:t>ppm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cadmium and 10</a:t>
            </a:r>
            <a:r>
              <a:rPr lang="en-IN" sz="1200" baseline="30000" dirty="0" smtClean="0">
                <a:latin typeface="Arial" pitchFamily="34" charset="0"/>
                <a:cs typeface="Arial" pitchFamily="34" charset="0"/>
              </a:rPr>
              <a:t>8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IN" sz="1200" i="1" dirty="0" smtClean="0">
                <a:latin typeface="Arial" pitchFamily="34" charset="0"/>
                <a:cs typeface="Arial" pitchFamily="34" charset="0"/>
              </a:rPr>
              <a:t>P. rettgeri </a:t>
            </a:r>
            <a:r>
              <a:rPr lang="en-IN" sz="1200" dirty="0" smtClean="0">
                <a:latin typeface="Arial" pitchFamily="34" charset="0"/>
                <a:cs typeface="Arial" pitchFamily="34" charset="0"/>
              </a:rPr>
              <a:t>cells per gram of soil (T2)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0</TotalTime>
  <Words>902</Words>
  <Application>Microsoft Office PowerPoint</Application>
  <PresentationFormat>On-screen Show (4:3)</PresentationFormat>
  <Paragraphs>175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hakti</dc:creator>
  <cp:lastModifiedBy>Bhakti</cp:lastModifiedBy>
  <cp:revision>86</cp:revision>
  <dcterms:created xsi:type="dcterms:W3CDTF">2021-11-10T07:43:08Z</dcterms:created>
  <dcterms:modified xsi:type="dcterms:W3CDTF">2021-11-23T10:54:01Z</dcterms:modified>
</cp:coreProperties>
</file>